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81" d="100"/>
          <a:sy n="81" d="100"/>
        </p:scale>
        <p:origin x="31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755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488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175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814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218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628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728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070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928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47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878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4ADA5-09A1-4C17-95F7-4A36F9F607C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ADEA20-FAA1-4756-8600-26F70149998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748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9937" y="277396"/>
            <a:ext cx="62966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pt-PT" sz="1200" b="1" dirty="0"/>
              <a:t>Supplementary material 4: </a:t>
            </a:r>
            <a:r>
              <a:rPr lang="pt-PT" sz="1200" dirty="0"/>
              <a:t>SRA Validation of  identified mutations in other mammals</a:t>
            </a:r>
            <a:endParaRPr kumimoji="0" lang="pt-PT" sz="12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99937" y="5505172"/>
            <a:ext cx="6460659" cy="3831158"/>
            <a:chOff x="99937" y="5505172"/>
            <a:chExt cx="6460659" cy="3831158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2"/>
            <a:srcRect l="50075" t="12239" r="6044" b="11980"/>
            <a:stretch/>
          </p:blipFill>
          <p:spPr>
            <a:xfrm>
              <a:off x="163970" y="6400424"/>
              <a:ext cx="6034214" cy="2935906"/>
            </a:xfrm>
            <a:prstGeom prst="rect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11" name="TextBox 10"/>
            <p:cNvSpPr txBox="1"/>
            <p:nvPr/>
          </p:nvSpPr>
          <p:spPr>
            <a:xfrm>
              <a:off x="99937" y="5505172"/>
              <a:ext cx="6460659" cy="9002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100" b="1" i="1" dirty="0" err="1"/>
                <a:t>Rhinolophus</a:t>
              </a:r>
              <a:r>
                <a:rPr lang="en-US" sz="1100" b="1" i="1" dirty="0"/>
                <a:t> </a:t>
              </a:r>
              <a:r>
                <a:rPr lang="en-US" sz="1100" b="1" i="1" dirty="0" err="1"/>
                <a:t>sinicus</a:t>
              </a:r>
              <a:r>
                <a:rPr lang="en-US" sz="1100" b="1" i="1" dirty="0"/>
                <a:t> </a:t>
              </a:r>
              <a:r>
                <a:rPr lang="pt-PT" sz="1100" b="1" dirty="0"/>
                <a:t>SRA confirmation of stop codon in exon 2.</a:t>
              </a:r>
            </a:p>
            <a:p>
              <a:pPr algn="just"/>
              <a:r>
                <a:rPr lang="pt-PT" sz="1050" dirty="0"/>
                <a:t>SRA searched</a:t>
              </a:r>
            </a:p>
            <a:p>
              <a:r>
                <a:rPr lang="pt-PT" sz="1050" b="1" dirty="0">
                  <a:cs typeface="Arial" panose="020B0604020202020204" pitchFamily="34" charset="0"/>
                </a:rPr>
                <a:t>SRR2278754</a:t>
              </a:r>
              <a:r>
                <a:rPr lang="pt-PT" sz="1050" dirty="0">
                  <a:cs typeface="Arial" panose="020B0604020202020204" pitchFamily="34" charset="0"/>
                </a:rPr>
                <a:t>- </a:t>
              </a:r>
              <a:r>
                <a:rPr lang="en-US" sz="1050" dirty="0">
                  <a:cs typeface="Arial" panose="020B0604020202020204" pitchFamily="34" charset="0"/>
                </a:rPr>
                <a:t>Institutes for advanced interdisciplinary research </a:t>
              </a:r>
              <a:r>
                <a:rPr lang="pt-PT" sz="1050" dirty="0">
                  <a:cs typeface="Arial" panose="020B0604020202020204" pitchFamily="34" charset="0"/>
                </a:rPr>
                <a:t>2016-09-06 </a:t>
              </a:r>
              <a:r>
                <a:rPr lang="pt-PT" sz="1050" b="1" dirty="0">
                  <a:cs typeface="Arial" panose="020B0604020202020204" pitchFamily="34" charset="0"/>
                </a:rPr>
                <a:t>Sample ID: </a:t>
              </a:r>
              <a:r>
                <a:rPr lang="en-US" sz="1000" dirty="0"/>
                <a:t>SAMN04038064</a:t>
              </a:r>
            </a:p>
            <a:p>
              <a:r>
                <a:rPr lang="pt-PT" sz="1050" b="1" dirty="0">
                  <a:cs typeface="Arial" panose="020B0604020202020204" pitchFamily="34" charset="0"/>
                </a:rPr>
                <a:t>SRR2278725- </a:t>
              </a:r>
              <a:r>
                <a:rPr lang="en-US" sz="1050" dirty="0">
                  <a:cs typeface="Arial" panose="020B0604020202020204" pitchFamily="34" charset="0"/>
                </a:rPr>
                <a:t>Institutes for advanced interdisciplinary research 2016-09-06 </a:t>
              </a:r>
              <a:r>
                <a:rPr lang="en-US" sz="1050" b="1" dirty="0">
                  <a:cs typeface="Arial" panose="020B0604020202020204" pitchFamily="34" charset="0"/>
                </a:rPr>
                <a:t>Sample ID: </a:t>
              </a:r>
              <a:r>
                <a:rPr lang="en-US" sz="1000" dirty="0"/>
                <a:t>SAMN04038064</a:t>
              </a:r>
            </a:p>
            <a:p>
              <a:r>
                <a:rPr lang="pt-PT" sz="1050" b="1" dirty="0">
                  <a:cs typeface="Arial" panose="020B0604020202020204" pitchFamily="34" charset="0"/>
                </a:rPr>
                <a:t>SRR2278692 - </a:t>
              </a:r>
              <a:r>
                <a:rPr lang="en-US" sz="1050" dirty="0">
                  <a:cs typeface="Arial" panose="020B0604020202020204" pitchFamily="34" charset="0"/>
                </a:rPr>
                <a:t>Institutes for advanced interdisciplinary research 2016-09-06 </a:t>
              </a:r>
              <a:r>
                <a:rPr lang="en-US" sz="1050" b="1" dirty="0">
                  <a:cs typeface="Arial" panose="020B0604020202020204" pitchFamily="34" charset="0"/>
                </a:rPr>
                <a:t>Sample ID: </a:t>
              </a:r>
              <a:r>
                <a:rPr lang="en-US" sz="1000" dirty="0"/>
                <a:t>SAMN04038064</a:t>
              </a:r>
              <a:endParaRPr lang="en-US" sz="1050" dirty="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3690254" y="6484069"/>
              <a:ext cx="179929" cy="28392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" name="Grupo 1"/>
          <p:cNvGrpSpPr/>
          <p:nvPr/>
        </p:nvGrpSpPr>
        <p:grpSpPr>
          <a:xfrm>
            <a:off x="188672" y="1060405"/>
            <a:ext cx="6480199" cy="3810163"/>
            <a:chOff x="188672" y="1060405"/>
            <a:chExt cx="6480199" cy="3810163"/>
          </a:xfrm>
        </p:grpSpPr>
        <p:grpSp>
          <p:nvGrpSpPr>
            <p:cNvPr id="8" name="Group 7"/>
            <p:cNvGrpSpPr/>
            <p:nvPr/>
          </p:nvGrpSpPr>
          <p:grpSpPr>
            <a:xfrm>
              <a:off x="188672" y="1060405"/>
              <a:ext cx="6480199" cy="3810163"/>
              <a:chOff x="88958" y="713731"/>
              <a:chExt cx="6480199" cy="3810163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3"/>
              <a:srcRect l="50220" t="12500" r="6744" b="11459"/>
              <a:stretch/>
            </p:blipFill>
            <p:spPr>
              <a:xfrm>
                <a:off x="88958" y="1457842"/>
                <a:ext cx="5976992" cy="2975344"/>
              </a:xfrm>
              <a:prstGeom prst="rect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108498" y="713731"/>
                <a:ext cx="6460659" cy="7463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100" b="1" i="1" dirty="0" err="1"/>
                  <a:t>Hipposideros</a:t>
                </a:r>
                <a:r>
                  <a:rPr lang="en-US" sz="1100" b="1" i="1" dirty="0"/>
                  <a:t> armiger </a:t>
                </a:r>
                <a:r>
                  <a:rPr lang="pt-PT" sz="1100" b="1" dirty="0"/>
                  <a:t>SRA confirmation of stop codon in exon 3.</a:t>
                </a:r>
              </a:p>
              <a:p>
                <a:pPr algn="just"/>
                <a:r>
                  <a:rPr lang="pt-PT" sz="1050" dirty="0"/>
                  <a:t>SRA searched</a:t>
                </a:r>
              </a:p>
              <a:p>
                <a:r>
                  <a:rPr lang="pt-PT" sz="1050" b="1" dirty="0">
                    <a:cs typeface="Arial" panose="020B0604020202020204" pitchFamily="34" charset="0"/>
                  </a:rPr>
                  <a:t>SRR3714308</a:t>
                </a:r>
                <a:r>
                  <a:rPr lang="pt-PT" sz="1050" dirty="0">
                    <a:cs typeface="Arial" panose="020B0604020202020204" pitchFamily="34" charset="0"/>
                  </a:rPr>
                  <a:t>- </a:t>
                </a:r>
                <a:r>
                  <a:rPr lang="en-US" sz="1050" dirty="0">
                    <a:cs typeface="Arial" panose="020B0604020202020204" pitchFamily="34" charset="0"/>
                  </a:rPr>
                  <a:t>Institutes for advanced interdisciplinary research </a:t>
                </a:r>
                <a:r>
                  <a:rPr lang="pt-PT" sz="1050" dirty="0">
                    <a:cs typeface="Arial" panose="020B0604020202020204" pitchFamily="34" charset="0"/>
                  </a:rPr>
                  <a:t>2016-12-12 </a:t>
                </a:r>
                <a:r>
                  <a:rPr lang="pt-PT" sz="1050" b="1" dirty="0">
                    <a:cs typeface="Arial" panose="020B0604020202020204" pitchFamily="34" charset="0"/>
                  </a:rPr>
                  <a:t>Sample ID: </a:t>
                </a:r>
                <a:r>
                  <a:rPr lang="pt-PT" sz="1050" dirty="0">
                    <a:cs typeface="Arial" panose="020B0604020202020204" pitchFamily="34" charset="0"/>
                  </a:rPr>
                  <a:t>SAMN04440424</a:t>
                </a:r>
              </a:p>
              <a:p>
                <a:r>
                  <a:rPr lang="pt-PT" sz="1050" b="1" dirty="0">
                    <a:cs typeface="Arial" panose="020B0604020202020204" pitchFamily="34" charset="0"/>
                  </a:rPr>
                  <a:t>SRR3714317- </a:t>
                </a:r>
                <a:r>
                  <a:rPr lang="en-US" sz="1050" dirty="0">
                    <a:cs typeface="Arial" panose="020B0604020202020204" pitchFamily="34" charset="0"/>
                  </a:rPr>
                  <a:t>Institutes for advanced interdisciplinary research 2016-12-12 </a:t>
                </a:r>
                <a:r>
                  <a:rPr lang="en-US" sz="1050" b="1" dirty="0">
                    <a:cs typeface="Arial" panose="020B0604020202020204" pitchFamily="34" charset="0"/>
                  </a:rPr>
                  <a:t>Sample ID: </a:t>
                </a:r>
                <a:r>
                  <a:rPr lang="en-US" sz="1000" dirty="0"/>
                  <a:t>SAMN04440409</a:t>
                </a:r>
                <a:endParaRPr lang="pt-PT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3462526" y="1400719"/>
                <a:ext cx="197922" cy="312317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4" name="Rectangle 6"/>
            <p:cNvSpPr/>
            <p:nvPr/>
          </p:nvSpPr>
          <p:spPr>
            <a:xfrm>
              <a:off x="5070114" y="1747393"/>
              <a:ext cx="76308" cy="312317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3739937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323033" y="5353187"/>
            <a:ext cx="6209173" cy="3418672"/>
            <a:chOff x="323033" y="5353187"/>
            <a:chExt cx="6209173" cy="3418672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/>
            <a:srcRect l="50214" t="19454" r="8293" b="17709"/>
            <a:stretch/>
          </p:blipFill>
          <p:spPr>
            <a:xfrm>
              <a:off x="323033" y="6122628"/>
              <a:ext cx="6209173" cy="2649231"/>
            </a:xfrm>
            <a:prstGeom prst="rect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7" name="Rectangle 6"/>
            <p:cNvSpPr/>
            <p:nvPr/>
          </p:nvSpPr>
          <p:spPr>
            <a:xfrm>
              <a:off x="323033" y="5353187"/>
              <a:ext cx="6178061" cy="76944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100" b="1" i="1" dirty="0" err="1"/>
                <a:t>Heterocephalus</a:t>
              </a:r>
              <a:r>
                <a:rPr lang="en-US" sz="1100" b="1" i="1" dirty="0"/>
                <a:t> </a:t>
              </a:r>
              <a:r>
                <a:rPr lang="en-US" sz="1100" b="1" i="1" dirty="0" err="1"/>
                <a:t>glaber</a:t>
              </a:r>
              <a:r>
                <a:rPr lang="en-US" sz="1100" b="1" i="1" dirty="0"/>
                <a:t> </a:t>
              </a:r>
              <a:r>
                <a:rPr lang="pt-PT" sz="1100" b="1" dirty="0"/>
                <a:t>SRA confirmation of stop codon in exon 2.</a:t>
              </a:r>
            </a:p>
            <a:p>
              <a:pPr algn="just"/>
              <a:r>
                <a:rPr lang="pt-PT" sz="1100" dirty="0"/>
                <a:t>SRA searched</a:t>
              </a:r>
            </a:p>
            <a:p>
              <a:r>
                <a:rPr lang="pt-PT" sz="1100" b="1" dirty="0">
                  <a:cs typeface="Arial" panose="020B0604020202020204" pitchFamily="34" charset="0"/>
                </a:rPr>
                <a:t>SRR122273</a:t>
              </a:r>
              <a:r>
                <a:rPr lang="pt-PT" sz="1100" dirty="0">
                  <a:cs typeface="Arial" panose="020B0604020202020204" pitchFamily="34" charset="0"/>
                </a:rPr>
                <a:t>- </a:t>
              </a:r>
              <a:r>
                <a:rPr lang="en-US" sz="1100" dirty="0">
                  <a:cs typeface="Arial" panose="020B0604020202020204" pitchFamily="34" charset="0"/>
                </a:rPr>
                <a:t> Beijing Genome Institute (BGI) </a:t>
              </a:r>
              <a:r>
                <a:rPr lang="pt-PT" sz="1100" dirty="0">
                  <a:cs typeface="Arial" panose="020B0604020202020204" pitchFamily="34" charset="0"/>
                </a:rPr>
                <a:t>2011-10-12 </a:t>
              </a:r>
              <a:r>
                <a:rPr lang="pt-PT" sz="1100" b="1" dirty="0">
                  <a:cs typeface="Arial" panose="020B0604020202020204" pitchFamily="34" charset="0"/>
                </a:rPr>
                <a:t>Sample ID: </a:t>
              </a:r>
              <a:r>
                <a:rPr lang="pt-PT" sz="1100" dirty="0">
                  <a:cs typeface="Arial" panose="020B0604020202020204" pitchFamily="34" charset="0"/>
                </a:rPr>
                <a:t>SAMN00217190</a:t>
              </a:r>
            </a:p>
            <a:p>
              <a:r>
                <a:rPr lang="pt-PT" sz="1100" b="1" dirty="0">
                  <a:cs typeface="Arial" panose="020B0604020202020204" pitchFamily="34" charset="0"/>
                </a:rPr>
                <a:t>SRR363833- </a:t>
              </a:r>
              <a:r>
                <a:rPr lang="en-US" sz="1100" dirty="0">
                  <a:cs typeface="Arial" panose="020B0604020202020204" pitchFamily="34" charset="0"/>
                </a:rPr>
                <a:t>Broad Institute (BI) </a:t>
              </a:r>
              <a:r>
                <a:rPr lang="pt-PT" sz="1100" dirty="0">
                  <a:cs typeface="Arial" panose="020B0604020202020204" pitchFamily="34" charset="0"/>
                </a:rPr>
                <a:t>2011-11-10 </a:t>
              </a:r>
              <a:r>
                <a:rPr lang="pt-PT" sz="1100" b="1" dirty="0">
                  <a:cs typeface="Arial" panose="020B0604020202020204" pitchFamily="34" charset="0"/>
                </a:rPr>
                <a:t>Sample ID: </a:t>
              </a:r>
              <a:r>
                <a:rPr lang="pt-PT" sz="1100" dirty="0">
                  <a:cs typeface="Arial" panose="020B0604020202020204" pitchFamily="34" charset="0"/>
                </a:rPr>
                <a:t>SAMN00714537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4749620" y="6143816"/>
              <a:ext cx="179220" cy="262804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197958" y="555189"/>
            <a:ext cx="6383674" cy="4050678"/>
            <a:chOff x="197958" y="555189"/>
            <a:chExt cx="6383674" cy="4050678"/>
          </a:xfrm>
        </p:grpSpPr>
        <p:grpSp>
          <p:nvGrpSpPr>
            <p:cNvPr id="5" name="Group 4"/>
            <p:cNvGrpSpPr/>
            <p:nvPr/>
          </p:nvGrpSpPr>
          <p:grpSpPr>
            <a:xfrm>
              <a:off x="197958" y="555189"/>
              <a:ext cx="6383674" cy="4050678"/>
              <a:chOff x="197958" y="555189"/>
              <a:chExt cx="6383674" cy="4050678"/>
            </a:xfrm>
          </p:grpSpPr>
          <p:sp>
            <p:nvSpPr>
              <p:cNvPr id="3" name="Rectangle 2"/>
              <p:cNvSpPr/>
              <p:nvPr/>
            </p:nvSpPr>
            <p:spPr>
              <a:xfrm>
                <a:off x="197958" y="555189"/>
                <a:ext cx="6178061" cy="76944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sz="1100" b="1" i="1" dirty="0" err="1"/>
                  <a:t>Trichechus</a:t>
                </a:r>
                <a:r>
                  <a:rPr lang="en-US" sz="1100" b="1" i="1" dirty="0"/>
                  <a:t> </a:t>
                </a:r>
                <a:r>
                  <a:rPr lang="en-US" sz="1100" b="1" i="1" dirty="0" err="1"/>
                  <a:t>manatus</a:t>
                </a:r>
                <a:r>
                  <a:rPr lang="en-US" sz="1100" b="1" i="1" dirty="0"/>
                  <a:t> </a:t>
                </a:r>
                <a:r>
                  <a:rPr lang="pt-PT" sz="1100" b="1" dirty="0"/>
                  <a:t>SRA confirmation of stop codon in exon 3.</a:t>
                </a:r>
              </a:p>
              <a:p>
                <a:pPr algn="just"/>
                <a:r>
                  <a:rPr lang="pt-PT" sz="1100" dirty="0"/>
                  <a:t>SRA searched</a:t>
                </a:r>
              </a:p>
              <a:p>
                <a:r>
                  <a:rPr lang="pt-PT" sz="1100" b="1" dirty="0">
                    <a:cs typeface="Arial" panose="020B0604020202020204" pitchFamily="34" charset="0"/>
                  </a:rPr>
                  <a:t>SRR307137</a:t>
                </a:r>
                <a:r>
                  <a:rPr lang="pt-PT" sz="1100" dirty="0">
                    <a:cs typeface="Arial" panose="020B0604020202020204" pitchFamily="34" charset="0"/>
                  </a:rPr>
                  <a:t>- </a:t>
                </a:r>
                <a:r>
                  <a:rPr lang="en-US" sz="1100" dirty="0">
                    <a:cs typeface="Arial" panose="020B0604020202020204" pitchFamily="34" charset="0"/>
                  </a:rPr>
                  <a:t>Broad Institute (BI) </a:t>
                </a:r>
                <a:r>
                  <a:rPr lang="pt-PT" sz="1100" dirty="0">
                    <a:cs typeface="Arial" panose="020B0604020202020204" pitchFamily="34" charset="0"/>
                  </a:rPr>
                  <a:t>2011-07-08 </a:t>
                </a:r>
                <a:r>
                  <a:rPr lang="pt-PT" sz="1100" b="1" dirty="0">
                    <a:cs typeface="Arial" panose="020B0604020202020204" pitchFamily="34" charset="0"/>
                  </a:rPr>
                  <a:t>Sample ID: </a:t>
                </a:r>
                <a:r>
                  <a:rPr lang="pt-PT" sz="1100" dirty="0">
                    <a:cs typeface="Arial" panose="020B0604020202020204" pitchFamily="34" charset="0"/>
                  </a:rPr>
                  <a:t>SAMN00632092</a:t>
                </a:r>
              </a:p>
              <a:p>
                <a:r>
                  <a:rPr lang="pt-PT" sz="1100" b="1" dirty="0">
                    <a:cs typeface="Arial" panose="020B0604020202020204" pitchFamily="34" charset="0"/>
                  </a:rPr>
                  <a:t>SRR307135- </a:t>
                </a:r>
                <a:r>
                  <a:rPr lang="en-US" sz="1100" dirty="0">
                    <a:cs typeface="Arial" panose="020B0604020202020204" pitchFamily="34" charset="0"/>
                  </a:rPr>
                  <a:t>Broad Institute (BI) </a:t>
                </a:r>
                <a:r>
                  <a:rPr lang="pt-PT" sz="1100" dirty="0">
                    <a:cs typeface="Arial" panose="020B0604020202020204" pitchFamily="34" charset="0"/>
                  </a:rPr>
                  <a:t>2011-07-08 </a:t>
                </a:r>
                <a:r>
                  <a:rPr lang="pt-PT" sz="1100" b="1" dirty="0">
                    <a:cs typeface="Arial" panose="020B0604020202020204" pitchFamily="34" charset="0"/>
                  </a:rPr>
                  <a:t>Sample ID: </a:t>
                </a:r>
                <a:r>
                  <a:rPr lang="pt-PT" sz="1100" dirty="0">
                    <a:cs typeface="Arial" panose="020B0604020202020204" pitchFamily="34" charset="0"/>
                  </a:rPr>
                  <a:t>SAMN00632092</a:t>
                </a:r>
              </a:p>
            </p:txBody>
          </p:sp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3"/>
              <a:srcRect l="50203" t="15464" r="10563" b="13061"/>
              <a:stretch/>
            </p:blipFill>
            <p:spPr>
              <a:xfrm>
                <a:off x="323033" y="1393744"/>
                <a:ext cx="6258599" cy="3212123"/>
              </a:xfrm>
              <a:prstGeom prst="rect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</p:grpSp>
        <p:sp>
          <p:nvSpPr>
            <p:cNvPr id="9" name="Rectangle 8"/>
            <p:cNvSpPr/>
            <p:nvPr/>
          </p:nvSpPr>
          <p:spPr>
            <a:xfrm>
              <a:off x="4433668" y="1400578"/>
              <a:ext cx="216391" cy="320528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2829796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81250" y="729486"/>
            <a:ext cx="6178061" cy="4022623"/>
            <a:chOff x="181250" y="729486"/>
            <a:chExt cx="6178061" cy="4022623"/>
          </a:xfrm>
        </p:grpSpPr>
        <p:grpSp>
          <p:nvGrpSpPr>
            <p:cNvPr id="4" name="Group 3"/>
            <p:cNvGrpSpPr/>
            <p:nvPr/>
          </p:nvGrpSpPr>
          <p:grpSpPr>
            <a:xfrm>
              <a:off x="181250" y="729486"/>
              <a:ext cx="6178061" cy="4022623"/>
              <a:chOff x="181250" y="729486"/>
              <a:chExt cx="6178061" cy="4022623"/>
            </a:xfrm>
          </p:grpSpPr>
          <p:sp>
            <p:nvSpPr>
              <p:cNvPr id="2" name="Rectangle 1"/>
              <p:cNvSpPr/>
              <p:nvPr/>
            </p:nvSpPr>
            <p:spPr>
              <a:xfrm>
                <a:off x="181250" y="729486"/>
                <a:ext cx="6178061" cy="76944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sz="1100" b="1" i="1" dirty="0" err="1"/>
                  <a:t>Manis</a:t>
                </a:r>
                <a:r>
                  <a:rPr lang="en-US" sz="1100" b="1" i="1" dirty="0"/>
                  <a:t> </a:t>
                </a:r>
                <a:r>
                  <a:rPr lang="en-US" sz="1100" b="1" i="1" dirty="0" err="1"/>
                  <a:t>javanica</a:t>
                </a:r>
                <a:r>
                  <a:rPr lang="en-US" sz="1100" b="1" i="1" dirty="0"/>
                  <a:t> </a:t>
                </a:r>
                <a:r>
                  <a:rPr lang="pt-PT" sz="1100" b="1" dirty="0"/>
                  <a:t>SRA confirmation of 2nt deletion exon2</a:t>
                </a:r>
              </a:p>
              <a:p>
                <a:pPr algn="just"/>
                <a:r>
                  <a:rPr lang="pt-PT" sz="1100" dirty="0"/>
                  <a:t>SRA searched</a:t>
                </a:r>
              </a:p>
              <a:p>
                <a:r>
                  <a:rPr lang="pt-PT" sz="1100" b="1" dirty="0">
                    <a:cs typeface="Arial" panose="020B0604020202020204" pitchFamily="34" charset="0"/>
                  </a:rPr>
                  <a:t>SRR3932068</a:t>
                </a:r>
                <a:r>
                  <a:rPr lang="pt-PT" sz="1100" dirty="0">
                    <a:cs typeface="Arial" panose="020B0604020202020204" pitchFamily="34" charset="0"/>
                  </a:rPr>
                  <a:t>- </a:t>
                </a:r>
                <a:r>
                  <a:rPr lang="en-US" sz="1100" dirty="0">
                    <a:cs typeface="Arial" panose="020B0604020202020204" pitchFamily="34" charset="0"/>
                  </a:rPr>
                  <a:t> University of Malaya </a:t>
                </a:r>
                <a:r>
                  <a:rPr lang="pt-PT" sz="1100" dirty="0">
                    <a:cs typeface="Arial" panose="020B0604020202020204" pitchFamily="34" charset="0"/>
                  </a:rPr>
                  <a:t>2016-07-25 </a:t>
                </a:r>
                <a:r>
                  <a:rPr lang="pt-PT" sz="1100" b="1" dirty="0">
                    <a:cs typeface="Arial" panose="020B0604020202020204" pitchFamily="34" charset="0"/>
                  </a:rPr>
                  <a:t>Sample ID: </a:t>
                </a:r>
                <a:r>
                  <a:rPr lang="pt-PT" sz="1100" dirty="0">
                    <a:cs typeface="Arial" panose="020B0604020202020204" pitchFamily="34" charset="0"/>
                  </a:rPr>
                  <a:t>SAMN02935387</a:t>
                </a:r>
              </a:p>
              <a:p>
                <a:r>
                  <a:rPr lang="pt-PT" sz="1100" b="1" dirty="0">
                    <a:cs typeface="Arial" panose="020B0604020202020204" pitchFamily="34" charset="0"/>
                  </a:rPr>
                  <a:t>SRR3932363- </a:t>
                </a:r>
                <a:r>
                  <a:rPr lang="en-US" sz="1100" dirty="0">
                    <a:cs typeface="Arial" panose="020B0604020202020204" pitchFamily="34" charset="0"/>
                  </a:rPr>
                  <a:t>University of Malaya </a:t>
                </a:r>
                <a:r>
                  <a:rPr lang="pt-PT" sz="1100" dirty="0">
                    <a:cs typeface="Arial" panose="020B0604020202020204" pitchFamily="34" charset="0"/>
                  </a:rPr>
                  <a:t>2016-07-25  </a:t>
                </a:r>
                <a:r>
                  <a:rPr lang="pt-PT" sz="1100" b="1" dirty="0">
                    <a:cs typeface="Arial" panose="020B0604020202020204" pitchFamily="34" charset="0"/>
                  </a:rPr>
                  <a:t>Sample ID: </a:t>
                </a:r>
                <a:r>
                  <a:rPr lang="pt-PT" sz="1100" dirty="0">
                    <a:cs typeface="Arial" panose="020B0604020202020204" pitchFamily="34" charset="0"/>
                  </a:rPr>
                  <a:t>SAMN02935387</a:t>
                </a:r>
              </a:p>
            </p:txBody>
          </p:sp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2"/>
              <a:srcRect l="50126" t="12649" r="9851" b="10119"/>
              <a:stretch/>
            </p:blipFill>
            <p:spPr>
              <a:xfrm>
                <a:off x="278428" y="1498927"/>
                <a:ext cx="5983707" cy="3253182"/>
              </a:xfrm>
              <a:prstGeom prst="rect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</p:grpSp>
        <p:sp>
          <p:nvSpPr>
            <p:cNvPr id="5" name="Rectangle 4"/>
            <p:cNvSpPr/>
            <p:nvPr/>
          </p:nvSpPr>
          <p:spPr>
            <a:xfrm>
              <a:off x="4214727" y="1546820"/>
              <a:ext cx="216391" cy="320528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558595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0</TotalTime>
  <Words>193</Words>
  <Application>Microsoft Macintosh PowerPoint</Application>
  <PresentationFormat>Papel A4 (210x297 mm)</PresentationFormat>
  <Paragraphs>22</Paragraphs>
  <Slides>3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Apresentação do PowerPoint</vt:lpstr>
      <vt:lpstr>Apresentação do PowerPoint</vt:lpstr>
      <vt:lpstr>Apresentação do PowerPoint</vt:lpstr>
    </vt:vector>
  </TitlesOfParts>
  <Company>Universidade do Porto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nica marques</dc:creator>
  <cp:lastModifiedBy>Utilizador do Microsoft Office</cp:lastModifiedBy>
  <cp:revision>12</cp:revision>
  <dcterms:created xsi:type="dcterms:W3CDTF">2018-08-01T10:57:16Z</dcterms:created>
  <dcterms:modified xsi:type="dcterms:W3CDTF">2019-01-21T11:08:36Z</dcterms:modified>
</cp:coreProperties>
</file>